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8803600" cy="162036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9E702-DEBC-4DE3-A47E-90B662ABE6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259236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440000" y="9365040"/>
            <a:ext cx="259236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B7295-1F0C-4D89-9C2B-C9C8B62DED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723280" y="37796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440000" y="93650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723280" y="93650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C3161-613F-4F47-AC7A-D4499CA675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834732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0204920" y="3779640"/>
            <a:ext cx="834732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970200" y="3779640"/>
            <a:ext cx="834732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440000" y="9365040"/>
            <a:ext cx="834732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0204920" y="9365040"/>
            <a:ext cx="834732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970200" y="9365040"/>
            <a:ext cx="834732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BE082-4D3C-42AC-BD60-11D4E0CCB6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440000" y="3779640"/>
            <a:ext cx="25923600" cy="1069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350"/>
              </a:spcBef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DEDBD-957D-45E6-B553-F140C0207A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25923600" cy="106930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52F68-A7D1-412A-83CF-176BF2D40C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12650400" cy="106930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723280" y="3779640"/>
            <a:ext cx="12650400" cy="106930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B3C148-C7E9-4AC3-A21F-036A133C17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302F3-A575-48F5-9ECC-C8FB8F35A2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440000" y="649080"/>
            <a:ext cx="25923600" cy="12518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350"/>
              </a:spcBef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C8DA8-6B01-4136-BDA5-661E795EA0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723280" y="3779640"/>
            <a:ext cx="12650400" cy="106930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440000" y="93650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3B85A-EAD3-4E36-8602-722D915184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12650400" cy="106930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723280" y="37796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723280" y="93650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5E49A-8F86-4D4A-ABFC-C9E04AED03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440000" y="37796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723280" y="3779640"/>
            <a:ext cx="126504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440000" y="9365040"/>
            <a:ext cx="25923600" cy="51004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/>
          </a:bodyPr>
          <a:p>
            <a:pPr indent="0">
              <a:spcBef>
                <a:spcPts val="2350"/>
              </a:spcBef>
              <a:buNone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5CF0B-38EA-4CE3-8F78-B4DB8D88CA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440000" y="649080"/>
            <a:ext cx="25923600" cy="270036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 algn="ctr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12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440000" y="3779640"/>
            <a:ext cx="25923600" cy="106930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t">
            <a:normAutofit fontScale="88000"/>
          </a:bodyPr>
          <a:p>
            <a:pPr marL="881640" indent="-881640">
              <a:spcBef>
                <a:spcPts val="2350"/>
              </a:spcBef>
              <a:buClr>
                <a:srgbClr val="000000"/>
              </a:buClr>
              <a:buFont typeface="Arial"/>
              <a:buChar char="•"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9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  <a:p>
            <a:pPr lvl="1" marL="1911240" indent="-734760">
              <a:spcBef>
                <a:spcPts val="2350"/>
              </a:spcBef>
              <a:buClr>
                <a:srgbClr val="000000"/>
              </a:buClr>
              <a:buFont typeface="Arial"/>
              <a:buChar char="–"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9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  <a:p>
            <a:pPr lvl="2" marL="2941920" indent="-588240">
              <a:spcBef>
                <a:spcPts val="2350"/>
              </a:spcBef>
              <a:buClr>
                <a:srgbClr val="000000"/>
              </a:buClr>
              <a:buFont typeface="Arial"/>
              <a:buChar char="•"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9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  <a:p>
            <a:pPr lvl="3" marL="4118400" indent="-588240">
              <a:spcBef>
                <a:spcPts val="2350"/>
              </a:spcBef>
              <a:buClr>
                <a:srgbClr val="000000"/>
              </a:buClr>
              <a:buFont typeface="Arial"/>
              <a:buChar char="–"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9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  <a:p>
            <a:pPr lvl="4" marL="5294520" indent="-588240">
              <a:spcBef>
                <a:spcPts val="2350"/>
              </a:spcBef>
              <a:buClr>
                <a:srgbClr val="000000"/>
              </a:buClr>
              <a:buFont typeface="Arial"/>
              <a:buChar char="»"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9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  <a:p>
            <a:pPr lvl="5" marL="5294520" indent="-588240">
              <a:spcBef>
                <a:spcPts val="2350"/>
              </a:spcBef>
              <a:buClr>
                <a:srgbClr val="000000"/>
              </a:buClr>
              <a:buFont typeface="Arial"/>
              <a:buChar char="»"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9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  <a:p>
            <a:pPr lvl="6" marL="5294520" indent="-588240">
              <a:spcBef>
                <a:spcPts val="2350"/>
              </a:spcBef>
              <a:buClr>
                <a:srgbClr val="000000"/>
              </a:buClr>
              <a:buFont typeface="Arial"/>
              <a:buChar char="»"/>
              <a:tabLst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en-US" sz="9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9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440000" y="15016320"/>
            <a:ext cx="6721200" cy="8632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  <a:defRPr b="0" lang="zh-CN" sz="3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0" lang="zh-CN" sz="35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840960" y="15016320"/>
            <a:ext cx="9121680" cy="8632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p>
            <a:pPr indent="0"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0642400" y="15016320"/>
            <a:ext cx="6721200" cy="863280"/>
          </a:xfrm>
          <a:prstGeom prst="rect">
            <a:avLst/>
          </a:prstGeom>
          <a:noFill/>
          <a:ln w="0">
            <a:noFill/>
          </a:ln>
        </p:spPr>
        <p:txBody>
          <a:bodyPr lIns="267480" rIns="267480" tIns="133560" bIns="1335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  <a:defRPr b="0" lang="zh-CN" sz="3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fld id="{49B43EF6-8FB8-4FE0-A248-45EF7E58F1C0}" type="slidenum">
              <a:rPr b="0" lang="zh-CN" sz="35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36720" y="3300480"/>
          <a:ext cx="27290520" cy="10488600"/>
        </p:xfrm>
        <a:graphic>
          <a:graphicData uri="http://schemas.openxmlformats.org/drawingml/2006/table">
            <a:tbl>
              <a:tblPr/>
              <a:tblGrid>
                <a:gridCol w="6823080"/>
                <a:gridCol w="6821280"/>
                <a:gridCol w="6823080"/>
                <a:gridCol w="6823080"/>
              </a:tblGrid>
              <a:tr h="1498680"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riation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NP ID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equency (%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8320"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DAR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V15I(c.43G&gt;A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15119519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0.9%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8680"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endParaRPr b="0" lang="en-US" sz="5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A291T (c.871G&gt;A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200267845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(0.9%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8680"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endParaRPr b="0" lang="en-US" sz="5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M107V(c.319A&gt;G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6176132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 (14.9%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8680"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endParaRPr b="0" lang="en-US" sz="5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V370A(c.1109T&gt;C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382776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3 (64.0%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6880"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endParaRPr b="0" lang="en-US" sz="5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S380R(c.1138A&gt;C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14656733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3.5%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8680"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DARADD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M9I (c.27G&gt;A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966365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00" rIns="21600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2673360"/>
                          <a:tab algn="l" pos="5346720"/>
                          <a:tab algn="l" pos="8020080"/>
                          <a:tab algn="l" pos="10693440"/>
                        </a:tabLst>
                      </a:pPr>
                      <a:r>
                        <a:rPr b="0" lang="en-US" sz="3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 (60.5%)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16000" marR="21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4"/>
          <p:cNvSpPr/>
          <p:nvPr/>
        </p:nvSpPr>
        <p:spPr>
          <a:xfrm>
            <a:off x="3168720" y="1836720"/>
            <a:ext cx="26084160" cy="107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67480" rIns="267480" tIns="133560" bIns="1335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673360"/>
                <a:tab algn="l" pos="5346720"/>
                <a:tab algn="l" pos="8020080"/>
                <a:tab algn="l" pos="10693440"/>
              </a:tabLst>
            </a:pPr>
            <a:r>
              <a:rPr b="1" lang="en-US" sz="5300" spc="-1" strike="noStrike">
                <a:solidFill>
                  <a:srgbClr val="000000"/>
                </a:solidFill>
                <a:latin typeface="Calibri"/>
              </a:rPr>
              <a:t>Table S1. Single nucleotide polymorphisms in </a:t>
            </a:r>
            <a:r>
              <a:rPr b="1" i="1" lang="en-US" sz="5300" spc="-1" strike="noStrike">
                <a:solidFill>
                  <a:srgbClr val="000000"/>
                </a:solidFill>
                <a:latin typeface="Calibri"/>
              </a:rPr>
              <a:t>EDAR</a:t>
            </a:r>
            <a:r>
              <a:rPr b="1" lang="en-US" sz="5300" spc="-1" strike="noStrike">
                <a:solidFill>
                  <a:srgbClr val="000000"/>
                </a:solidFill>
                <a:latin typeface="Calibri"/>
              </a:rPr>
              <a:t> and </a:t>
            </a:r>
            <a:r>
              <a:rPr b="1" i="1" lang="en-US" sz="5300" spc="-1" strike="noStrike">
                <a:solidFill>
                  <a:srgbClr val="000000"/>
                </a:solidFill>
                <a:latin typeface="Calibri"/>
              </a:rPr>
              <a:t>EDARADD</a:t>
            </a:r>
            <a:r>
              <a:rPr b="1" lang="en-US" sz="5300" spc="-1" strike="noStrike">
                <a:solidFill>
                  <a:srgbClr val="000000"/>
                </a:solidFill>
                <a:latin typeface="Calibri"/>
              </a:rPr>
              <a:t> of 114 patients </a:t>
            </a: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8T14:07:18Z</dcterms:created>
  <dc:creator>think</dc:creator>
  <dc:description/>
  <dc:language>en-US</dc:language>
  <cp:lastModifiedBy>think</cp:lastModifiedBy>
  <dcterms:modified xsi:type="dcterms:W3CDTF">2013-09-09T13:40:18Z</dcterms:modified>
  <cp:revision>6</cp:revision>
  <dc:subject/>
  <dc:title>幻灯片 1</dc:title>
</cp:coreProperties>
</file>